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78" d="100"/>
          <a:sy n="78" d="100"/>
        </p:scale>
        <p:origin x="8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5187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3764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149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673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100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3908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130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0260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73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903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776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1055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95444" y="160544"/>
            <a:ext cx="3469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17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6848" y="788347"/>
            <a:ext cx="8033640" cy="53348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685528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326572" y="431620"/>
            <a:ext cx="8523514" cy="17502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2. </a:t>
            </a:r>
            <a:r>
              <a:rPr lang="en-US" altLang="ja-JP" sz="1400" b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Xe</a:t>
            </a: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CT theory </a:t>
            </a:r>
            <a:endParaRPr lang="ja-JP" altLang="ja-JP" sz="14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indent="66675"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y applying the Fick principle, a single blood supply model (inflow: arterial only, outflow: venous) can be fitted to a dual blood supply model (inflow: arterial and portal venous) to separately determine HATBF (ml/100 ml/min) and PVTBF (ml/100 ml/min).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58353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1</Words>
  <Application>Microsoft Office PowerPoint</Application>
  <PresentationFormat>画面に合わせる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重福 隆太</dc:creator>
  <cp:lastModifiedBy>重福 隆太</cp:lastModifiedBy>
  <cp:revision>4</cp:revision>
  <dcterms:created xsi:type="dcterms:W3CDTF">2021-10-17T09:25:07Z</dcterms:created>
  <dcterms:modified xsi:type="dcterms:W3CDTF">2021-12-23T16:41:43Z</dcterms:modified>
</cp:coreProperties>
</file>